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685"/>
    <p:restoredTop sz="94631"/>
  </p:normalViewPr>
  <p:slideViewPr>
    <p:cSldViewPr>
      <p:cViewPr varScale="1">
        <p:scale>
          <a:sx n="69" d="100"/>
          <a:sy n="69" d="100"/>
        </p:scale>
        <p:origin x="1530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7198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5116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55759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92829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9526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2051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0764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33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657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1399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10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5FA31-A290-4574-94E6-0F9A4D912792}" type="datetimeFigureOut">
              <a:rPr lang="en-AU" smtClean="0"/>
              <a:t>5/0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848DEE-6A20-4288-9F2C-1B605CE2C1B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9790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12" y="260648"/>
            <a:ext cx="1986892" cy="167906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2973" y="271048"/>
            <a:ext cx="1986892" cy="167906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276013"/>
            <a:ext cx="2016224" cy="17038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2240" y="300800"/>
            <a:ext cx="1986892" cy="167906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1988840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1 LDLR 	       Gel 1 Actin		Gel 2 LDLR	Gel 2 Acti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27258" y="4797152"/>
            <a:ext cx="8208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3 LDLR 	              Gel 3 Actin		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467544" y="476672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1115616" y="686019"/>
            <a:ext cx="57606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67717" y="686019"/>
            <a:ext cx="47589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2699792" y="477928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3347864" y="687275"/>
            <a:ext cx="57606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2799965" y="687275"/>
            <a:ext cx="47589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4860032" y="699373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5652120" y="901907"/>
            <a:ext cx="456187" cy="681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4932040" y="909601"/>
            <a:ext cx="670292" cy="207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6936429" y="476672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24" name="Straight Connector 23"/>
          <p:cNvCxnSpPr/>
          <p:nvPr/>
        </p:nvCxnSpPr>
        <p:spPr>
          <a:xfrm flipV="1">
            <a:off x="7728517" y="679206"/>
            <a:ext cx="456187" cy="681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7008437" y="686900"/>
            <a:ext cx="670292" cy="207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contrast="-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87" t="15547" r="12566" b="18008"/>
          <a:stretch/>
        </p:blipFill>
        <p:spPr>
          <a:xfrm>
            <a:off x="186562" y="2857616"/>
            <a:ext cx="1979842" cy="1867528"/>
          </a:xfrm>
          <a:prstGeom prst="rect">
            <a:avLst/>
          </a:prstGeom>
        </p:spPr>
      </p:pic>
      <p:cxnSp>
        <p:nvCxnSpPr>
          <p:cNvPr id="29" name="Straight Connector 28"/>
          <p:cNvCxnSpPr/>
          <p:nvPr/>
        </p:nvCxnSpPr>
        <p:spPr>
          <a:xfrm>
            <a:off x="1163487" y="2996952"/>
            <a:ext cx="600201" cy="571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29771" y="2996952"/>
            <a:ext cx="71383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341317" y="2787605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     Treated</a:t>
            </a:r>
            <a:r>
              <a:rPr lang="en-US" sz="1050" b="1" dirty="0"/>
              <a:t>	 	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contrast="-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403" t="18006" r="16723" b="15545"/>
          <a:stretch/>
        </p:blipFill>
        <p:spPr>
          <a:xfrm>
            <a:off x="2412377" y="2857617"/>
            <a:ext cx="2015607" cy="188974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2699792" y="2840714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3420180" y="3050061"/>
            <a:ext cx="64776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583941" y="3050061"/>
            <a:ext cx="76392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763688" y="950531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LDLR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115009" y="977069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LDLR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849585" y="3560402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LDLR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169476" y="1205932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908485" y="1243174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233298" y="4172365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8" name="Rectangle 7"/>
          <p:cNvSpPr/>
          <p:nvPr/>
        </p:nvSpPr>
        <p:spPr>
          <a:xfrm>
            <a:off x="467543" y="5795724"/>
            <a:ext cx="805306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>
                <a:solidFill>
                  <a:srgbClr val="1D2228"/>
                </a:solidFill>
                <a:latin typeface="Helvetica Neue"/>
              </a:rPr>
              <a:t>Membranes were probed for LDLR then subsequently for actin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8212461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260648"/>
            <a:ext cx="2088232" cy="176470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752" y="236290"/>
            <a:ext cx="2160240" cy="182555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236289"/>
            <a:ext cx="2160240" cy="182555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8264" y="236289"/>
            <a:ext cx="2195736" cy="185555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9374" y="2132856"/>
            <a:ext cx="9004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1 </a:t>
            </a:r>
            <a:r>
              <a:rPr lang="en-AU" dirty="0" err="1"/>
              <a:t>HMGCoA</a:t>
            </a:r>
            <a:r>
              <a:rPr lang="en-AU" dirty="0"/>
              <a:t> 	          Gel 1 Actin		Gel 2 </a:t>
            </a:r>
            <a:r>
              <a:rPr lang="en-AU" dirty="0" err="1"/>
              <a:t>HMGCoA</a:t>
            </a:r>
            <a:r>
              <a:rPr lang="en-AU" dirty="0"/>
              <a:t>	        Gel 2   Actin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01" y="2708921"/>
            <a:ext cx="2107735" cy="178118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7870" y="2708921"/>
            <a:ext cx="2182122" cy="184404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75886" y="4653136"/>
            <a:ext cx="9004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3  </a:t>
            </a:r>
            <a:r>
              <a:rPr lang="en-AU" dirty="0" err="1"/>
              <a:t>HMGCoA</a:t>
            </a:r>
            <a:r>
              <a:rPr lang="en-AU" dirty="0"/>
              <a:t> 	          Gel 3  Actin		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467544" y="627365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1065574" y="836712"/>
            <a:ext cx="625518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95709" y="836712"/>
            <a:ext cx="547899" cy="681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2699792" y="699373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3297822" y="902787"/>
            <a:ext cx="625518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2727957" y="902787"/>
            <a:ext cx="547899" cy="681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4953663" y="699373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22" name="Straight Connector 21"/>
          <p:cNvCxnSpPr/>
          <p:nvPr/>
        </p:nvCxnSpPr>
        <p:spPr>
          <a:xfrm flipV="1">
            <a:off x="5721024" y="901907"/>
            <a:ext cx="456187" cy="681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V="1">
            <a:off x="4981828" y="909601"/>
            <a:ext cx="670292" cy="207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7236296" y="699373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28" name="Straight Connector 27"/>
          <p:cNvCxnSpPr/>
          <p:nvPr/>
        </p:nvCxnSpPr>
        <p:spPr>
          <a:xfrm flipV="1">
            <a:off x="8003657" y="911271"/>
            <a:ext cx="456187" cy="681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V="1">
            <a:off x="7264461" y="918965"/>
            <a:ext cx="670292" cy="207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395536" y="3008274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993566" y="3217621"/>
            <a:ext cx="625518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423701" y="3217621"/>
            <a:ext cx="547899" cy="681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2627784" y="3060549"/>
            <a:ext cx="158417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ontrol          Treated</a:t>
            </a:r>
            <a:r>
              <a:rPr lang="en-US" sz="1050" b="1" dirty="0"/>
              <a:t>	 	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3225814" y="3269896"/>
            <a:ext cx="625518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2655949" y="3269896"/>
            <a:ext cx="547899" cy="681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691680" y="1052736"/>
            <a:ext cx="892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err="1" smtClean="0"/>
              <a:t>HMGCoA</a:t>
            </a:r>
            <a:endParaRPr lang="en-AU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6183751" y="1084957"/>
            <a:ext cx="892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err="1" smtClean="0"/>
              <a:t>HMGCoA</a:t>
            </a:r>
            <a:endParaRPr lang="en-AU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1605589" y="3492566"/>
            <a:ext cx="892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err="1" smtClean="0"/>
              <a:t>HMGCoA</a:t>
            </a:r>
            <a:endParaRPr lang="en-AU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4026950" y="934272"/>
            <a:ext cx="892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8549999" y="961846"/>
            <a:ext cx="892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4015438" y="3433799"/>
            <a:ext cx="8922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9" name="Rectangle 8"/>
          <p:cNvSpPr/>
          <p:nvPr/>
        </p:nvSpPr>
        <p:spPr>
          <a:xfrm>
            <a:off x="211850" y="5791467"/>
            <a:ext cx="824799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 smtClean="0">
                <a:solidFill>
                  <a:srgbClr val="1D2228"/>
                </a:solidFill>
                <a:latin typeface="Helvetica Neue"/>
              </a:rPr>
              <a:t>Membranes </a:t>
            </a:r>
            <a:r>
              <a:rPr lang="en-AU" dirty="0">
                <a:solidFill>
                  <a:srgbClr val="1D2228"/>
                </a:solidFill>
                <a:latin typeface="Helvetica Neue"/>
              </a:rPr>
              <a:t>were cut and probed simultaneously for </a:t>
            </a:r>
            <a:r>
              <a:rPr lang="en-AU" dirty="0" err="1">
                <a:solidFill>
                  <a:srgbClr val="1D2228"/>
                </a:solidFill>
                <a:latin typeface="Helvetica Neue"/>
              </a:rPr>
              <a:t>HMGCoA</a:t>
            </a:r>
            <a:r>
              <a:rPr lang="en-AU" dirty="0">
                <a:solidFill>
                  <a:srgbClr val="1D2228"/>
                </a:solidFill>
                <a:latin typeface="Helvetica Neue"/>
              </a:rPr>
              <a:t> and actin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202493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07398BC-C026-594B-8919-6DBC676EA76F}"/>
              </a:ext>
            </a:extLst>
          </p:cNvPr>
          <p:cNvSpPr txBox="1"/>
          <p:nvPr/>
        </p:nvSpPr>
        <p:spPr>
          <a:xfrm>
            <a:off x="1539351" y="213589"/>
            <a:ext cx="1592489" cy="530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RB1-Gel 1</a:t>
            </a:r>
          </a:p>
          <a:p>
            <a:endParaRPr lang="en-US" sz="105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68A4954-D22C-B84A-AE37-B690E1A2CD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890" r="5884" b="49256"/>
          <a:stretch/>
        </p:blipFill>
        <p:spPr>
          <a:xfrm>
            <a:off x="539551" y="602241"/>
            <a:ext cx="3888433" cy="195751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1151146" y="942719"/>
            <a:ext cx="27354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    Treated 	                         Control       MW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5C733C-5372-0E41-8DAE-82D9FA77BFCA}"/>
              </a:ext>
            </a:extLst>
          </p:cNvPr>
          <p:cNvSpPr txBox="1"/>
          <p:nvPr/>
        </p:nvSpPr>
        <p:spPr>
          <a:xfrm>
            <a:off x="3886640" y="1361727"/>
            <a:ext cx="343364" cy="12349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dirty="0"/>
              <a:t>250</a:t>
            </a:r>
          </a:p>
          <a:p>
            <a:r>
              <a:rPr lang="en-US" sz="825" dirty="0"/>
              <a:t>150</a:t>
            </a:r>
          </a:p>
          <a:p>
            <a:endParaRPr lang="en-US" sz="825" dirty="0"/>
          </a:p>
          <a:p>
            <a:r>
              <a:rPr lang="en-US" sz="825" dirty="0"/>
              <a:t>100</a:t>
            </a:r>
          </a:p>
          <a:p>
            <a:endParaRPr lang="en-US" sz="825" dirty="0"/>
          </a:p>
          <a:p>
            <a:r>
              <a:rPr lang="en-US" sz="825" dirty="0"/>
              <a:t>75</a:t>
            </a:r>
          </a:p>
          <a:p>
            <a:endParaRPr lang="en-US" sz="825" dirty="0"/>
          </a:p>
          <a:p>
            <a:endParaRPr lang="en-US" sz="825" dirty="0"/>
          </a:p>
          <a:p>
            <a:endParaRPr lang="en-US" sz="825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C674451-BE2F-9840-A970-63B8CB91C993}"/>
              </a:ext>
            </a:extLst>
          </p:cNvPr>
          <p:cNvSpPr txBox="1"/>
          <p:nvPr/>
        </p:nvSpPr>
        <p:spPr>
          <a:xfrm>
            <a:off x="681103" y="1933037"/>
            <a:ext cx="401072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dirty="0"/>
              <a:t>SRB1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2473756" y="1162010"/>
            <a:ext cx="10801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251319" y="1162805"/>
            <a:ext cx="10801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>
            <a:extLst>
              <a:ext uri="{FF2B5EF4-FFF2-40B4-BE49-F238E27FC236}">
                <a16:creationId xmlns:a16="http://schemas.microsoft.com/office/drawing/2014/main" id="{9A4BDFC9-D0A2-FD40-87B5-8A4D8ACFD3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577" t="9679" r="6618" b="43656"/>
          <a:stretch/>
        </p:blipFill>
        <p:spPr>
          <a:xfrm>
            <a:off x="467543" y="3212976"/>
            <a:ext cx="3960441" cy="18002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99953A6-CF1D-654C-B1F7-085671516D69}"/>
              </a:ext>
            </a:extLst>
          </p:cNvPr>
          <p:cNvSpPr txBox="1"/>
          <p:nvPr/>
        </p:nvSpPr>
        <p:spPr>
          <a:xfrm>
            <a:off x="1608980" y="2798449"/>
            <a:ext cx="1212191" cy="530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RB1-Gel 2</a:t>
            </a:r>
          </a:p>
          <a:p>
            <a:endParaRPr lang="en-US" sz="105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BDE4DC-69AC-FB45-9E2D-5D54180F354F}"/>
              </a:ext>
            </a:extLst>
          </p:cNvPr>
          <p:cNvSpPr txBox="1"/>
          <p:nvPr/>
        </p:nvSpPr>
        <p:spPr>
          <a:xfrm>
            <a:off x="676479" y="4472947"/>
            <a:ext cx="401072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dirty="0"/>
              <a:t>SRB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041E852-375C-1347-A742-31EDC1C3DF42}"/>
              </a:ext>
            </a:extLst>
          </p:cNvPr>
          <p:cNvSpPr txBox="1"/>
          <p:nvPr/>
        </p:nvSpPr>
        <p:spPr>
          <a:xfrm>
            <a:off x="3865392" y="3867011"/>
            <a:ext cx="343364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dirty="0"/>
              <a:t>250</a:t>
            </a:r>
          </a:p>
          <a:p>
            <a:r>
              <a:rPr lang="en-US" sz="825" dirty="0"/>
              <a:t>150</a:t>
            </a:r>
          </a:p>
          <a:p>
            <a:endParaRPr lang="en-US" sz="825" dirty="0"/>
          </a:p>
          <a:p>
            <a:r>
              <a:rPr lang="en-US" sz="825" dirty="0"/>
              <a:t>100</a:t>
            </a:r>
          </a:p>
          <a:p>
            <a:endParaRPr lang="en-US" sz="825" dirty="0"/>
          </a:p>
          <a:p>
            <a:r>
              <a:rPr lang="en-US" sz="825" dirty="0"/>
              <a:t>75</a:t>
            </a:r>
          </a:p>
          <a:p>
            <a:endParaRPr lang="en-US" sz="825" dirty="0"/>
          </a:p>
          <a:p>
            <a:endParaRPr lang="en-US" sz="825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1078865" y="3501008"/>
            <a:ext cx="273549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          Treated 	                      Control          MW 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2401475" y="3720299"/>
            <a:ext cx="10801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1179038" y="3721094"/>
            <a:ext cx="108012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007" b="25591"/>
          <a:stretch/>
        </p:blipFill>
        <p:spPr>
          <a:xfrm>
            <a:off x="4933333" y="602241"/>
            <a:ext cx="3663190" cy="1994439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5442813" y="1086852"/>
            <a:ext cx="234159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               Treated                     Control</a:t>
            </a:r>
          </a:p>
        </p:txBody>
      </p:sp>
      <p:cxnSp>
        <p:nvCxnSpPr>
          <p:cNvPr id="25" name="Straight Connector 24"/>
          <p:cNvCxnSpPr/>
          <p:nvPr/>
        </p:nvCxnSpPr>
        <p:spPr>
          <a:xfrm>
            <a:off x="6761678" y="1387478"/>
            <a:ext cx="102273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695144" y="1376944"/>
            <a:ext cx="91417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266217" y="190045"/>
            <a:ext cx="15121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1 Actin	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000" b="28000"/>
          <a:stretch/>
        </p:blipFill>
        <p:spPr>
          <a:xfrm>
            <a:off x="4906200" y="3212976"/>
            <a:ext cx="3623023" cy="18002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5208631" y="3627966"/>
            <a:ext cx="587696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                     </a:t>
            </a:r>
            <a:r>
              <a:rPr lang="en-US" sz="1050" b="1" dirty="0"/>
              <a:t>Treated                      Control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6577364" y="3941251"/>
            <a:ext cx="10115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5522525" y="3931844"/>
            <a:ext cx="90414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237960" y="2854677"/>
            <a:ext cx="15121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2 Actin	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812360" y="1772816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783064" y="4375067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2" name="Rectangle 1"/>
          <p:cNvSpPr/>
          <p:nvPr/>
        </p:nvSpPr>
        <p:spPr>
          <a:xfrm>
            <a:off x="448249" y="5588647"/>
            <a:ext cx="81482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>
                <a:solidFill>
                  <a:srgbClr val="1D2228"/>
                </a:solidFill>
                <a:latin typeface="Helvetica Neue"/>
              </a:rPr>
              <a:t>Membranes were cut and probed simultaneously for SRB1 and actin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3990803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9DC8BB2-02B7-E248-84DA-5A55BE380620}"/>
              </a:ext>
            </a:extLst>
          </p:cNvPr>
          <p:cNvSpPr txBox="1"/>
          <p:nvPr/>
        </p:nvSpPr>
        <p:spPr>
          <a:xfrm>
            <a:off x="1657375" y="514656"/>
            <a:ext cx="1212191" cy="530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RB1-Gel 3</a:t>
            </a:r>
          </a:p>
          <a:p>
            <a:endParaRPr lang="en-US" sz="1050" dirty="0"/>
          </a:p>
        </p:txBody>
      </p:sp>
      <p:grpSp>
        <p:nvGrpSpPr>
          <p:cNvPr id="3" name="Group 2"/>
          <p:cNvGrpSpPr/>
          <p:nvPr/>
        </p:nvGrpSpPr>
        <p:grpSpPr>
          <a:xfrm>
            <a:off x="107128" y="878838"/>
            <a:ext cx="4562475" cy="2074302"/>
            <a:chOff x="0" y="1939409"/>
            <a:chExt cx="4562475" cy="207430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0BA37A7-5ED7-D34E-A7FC-794B7087EE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48319"/>
            <a:stretch/>
          </p:blipFill>
          <p:spPr>
            <a:xfrm>
              <a:off x="0" y="1939409"/>
              <a:ext cx="4562475" cy="199364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7B18B5D-9FCF-BE42-9E27-00175CFC4EF3}"/>
                </a:ext>
              </a:extLst>
            </p:cNvPr>
            <p:cNvSpPr txBox="1"/>
            <p:nvPr/>
          </p:nvSpPr>
          <p:spPr>
            <a:xfrm>
              <a:off x="577921" y="3384694"/>
              <a:ext cx="401072" cy="2192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SRB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CA0699F-15F7-6B4A-B0F5-D4F64962A806}"/>
                </a:ext>
              </a:extLst>
            </p:cNvPr>
            <p:cNvSpPr txBox="1"/>
            <p:nvPr/>
          </p:nvSpPr>
          <p:spPr>
            <a:xfrm>
              <a:off x="3837057" y="2778758"/>
              <a:ext cx="343364" cy="1234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250</a:t>
              </a:r>
            </a:p>
            <a:p>
              <a:r>
                <a:rPr lang="en-US" sz="825" dirty="0"/>
                <a:t>150</a:t>
              </a:r>
            </a:p>
            <a:p>
              <a:endParaRPr lang="en-US" sz="825" dirty="0"/>
            </a:p>
            <a:p>
              <a:r>
                <a:rPr lang="en-US" sz="825" dirty="0"/>
                <a:t>100</a:t>
              </a:r>
            </a:p>
            <a:p>
              <a:endParaRPr lang="en-US" sz="825" dirty="0"/>
            </a:p>
            <a:p>
              <a:r>
                <a:rPr lang="en-US" sz="825" dirty="0"/>
                <a:t>75</a:t>
              </a:r>
            </a:p>
            <a:p>
              <a:endParaRPr lang="en-US" sz="825" dirty="0"/>
            </a:p>
            <a:p>
              <a:endParaRPr lang="en-US" sz="825" dirty="0"/>
            </a:p>
            <a:p>
              <a:r>
                <a:rPr lang="en-US" sz="825" dirty="0"/>
                <a:t>5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7506280-6CA4-D949-AA1C-6D9A222A104D}"/>
                </a:ext>
              </a:extLst>
            </p:cNvPr>
            <p:cNvSpPr txBox="1"/>
            <p:nvPr/>
          </p:nvSpPr>
          <p:spPr>
            <a:xfrm>
              <a:off x="1017142" y="2455004"/>
              <a:ext cx="273549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        Treated 	                         Control       MW </a:t>
              </a: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2483768" y="2674295"/>
              <a:ext cx="93610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1117315" y="2675090"/>
              <a:ext cx="108012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107127" y="3035726"/>
            <a:ext cx="4562475" cy="2481175"/>
            <a:chOff x="4562475" y="1558461"/>
            <a:chExt cx="4562475" cy="248117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1C1ED1D-F6E8-CD41-98D2-E8701DF7DE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48319"/>
            <a:stretch/>
          </p:blipFill>
          <p:spPr>
            <a:xfrm>
              <a:off x="4562475" y="1939409"/>
              <a:ext cx="4562475" cy="1993647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4B062B2-F5FA-AE41-8D3D-C5B26B7EFEDE}"/>
                </a:ext>
              </a:extLst>
            </p:cNvPr>
            <p:cNvSpPr txBox="1"/>
            <p:nvPr/>
          </p:nvSpPr>
          <p:spPr>
            <a:xfrm>
              <a:off x="6219036" y="1558461"/>
              <a:ext cx="1212191" cy="530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RB1-Gel 4</a:t>
              </a:r>
            </a:p>
            <a:p>
              <a:endParaRPr lang="en-US" sz="105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50A5822-E270-D94D-BCF2-B5A8E5F434EF}"/>
                </a:ext>
              </a:extLst>
            </p:cNvPr>
            <p:cNvSpPr txBox="1"/>
            <p:nvPr/>
          </p:nvSpPr>
          <p:spPr>
            <a:xfrm>
              <a:off x="5479828" y="3384693"/>
              <a:ext cx="401072" cy="2192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SRB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41E68B4-1BC6-C347-869D-A62A82A4293B}"/>
                </a:ext>
              </a:extLst>
            </p:cNvPr>
            <p:cNvSpPr txBox="1"/>
            <p:nvPr/>
          </p:nvSpPr>
          <p:spPr>
            <a:xfrm>
              <a:off x="7974918" y="2804683"/>
              <a:ext cx="343364" cy="12349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25" dirty="0"/>
                <a:t>250</a:t>
              </a:r>
            </a:p>
            <a:p>
              <a:r>
                <a:rPr lang="en-US" sz="825" dirty="0"/>
                <a:t>150</a:t>
              </a:r>
            </a:p>
            <a:p>
              <a:endParaRPr lang="en-US" sz="825" dirty="0"/>
            </a:p>
            <a:p>
              <a:r>
                <a:rPr lang="en-US" sz="825" dirty="0"/>
                <a:t>100</a:t>
              </a:r>
            </a:p>
            <a:p>
              <a:endParaRPr lang="en-US" sz="825" dirty="0"/>
            </a:p>
            <a:p>
              <a:r>
                <a:rPr lang="en-US" sz="825" dirty="0"/>
                <a:t>75</a:t>
              </a:r>
            </a:p>
            <a:p>
              <a:endParaRPr lang="en-US" sz="825" dirty="0"/>
            </a:p>
            <a:p>
              <a:endParaRPr lang="en-US" sz="825" dirty="0"/>
            </a:p>
            <a:p>
              <a:r>
                <a:rPr lang="en-US" sz="825" dirty="0"/>
                <a:t>5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7506280-6CA4-D949-AA1C-6D9A222A104D}"/>
                </a:ext>
              </a:extLst>
            </p:cNvPr>
            <p:cNvSpPr txBox="1"/>
            <p:nvPr/>
          </p:nvSpPr>
          <p:spPr>
            <a:xfrm>
              <a:off x="5580112" y="2455004"/>
              <a:ext cx="273549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          Treated 	                 Control       MW 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6902722" y="2674295"/>
              <a:ext cx="69361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5880900" y="2674295"/>
              <a:ext cx="879505" cy="795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51" b="25683"/>
          <a:stretch/>
        </p:blipFill>
        <p:spPr>
          <a:xfrm>
            <a:off x="4839971" y="878838"/>
            <a:ext cx="2856852" cy="199282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7506280-6CA4-D949-AA1C-6D9A222A104D}"/>
              </a:ext>
            </a:extLst>
          </p:cNvPr>
          <p:cNvSpPr txBox="1"/>
          <p:nvPr/>
        </p:nvSpPr>
        <p:spPr>
          <a:xfrm>
            <a:off x="5516961" y="1268760"/>
            <a:ext cx="1679331" cy="301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    </a:t>
            </a:r>
            <a:r>
              <a:rPr lang="en-US" sz="1050" b="1" dirty="0"/>
              <a:t>Treated        Control</a:t>
            </a:r>
          </a:p>
        </p:txBody>
      </p:sp>
      <p:cxnSp>
        <p:nvCxnSpPr>
          <p:cNvPr id="25" name="Straight Connector 24"/>
          <p:cNvCxnSpPr/>
          <p:nvPr/>
        </p:nvCxnSpPr>
        <p:spPr>
          <a:xfrm>
            <a:off x="5552917" y="1638004"/>
            <a:ext cx="7129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6384686" y="1631512"/>
            <a:ext cx="71294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629238" y="503267"/>
            <a:ext cx="15121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3 Actin	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4822199" y="3416673"/>
            <a:ext cx="5310255" cy="1993648"/>
            <a:chOff x="5173449" y="3645024"/>
            <a:chExt cx="4134900" cy="1296144"/>
          </a:xfrm>
        </p:grpSpPr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734" b="23989"/>
            <a:stretch/>
          </p:blipFill>
          <p:spPr>
            <a:xfrm>
              <a:off x="5173449" y="3645024"/>
              <a:ext cx="2314193" cy="1296144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7506280-6CA4-D949-AA1C-6D9A222A104D}"/>
                </a:ext>
              </a:extLst>
            </p:cNvPr>
            <p:cNvSpPr txBox="1"/>
            <p:nvPr/>
          </p:nvSpPr>
          <p:spPr>
            <a:xfrm>
              <a:off x="5554459" y="3956109"/>
              <a:ext cx="3753890" cy="1983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/>
                <a:t>              Treated      Control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6391094" y="4115467"/>
              <a:ext cx="405753" cy="5722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5899457" y="4116352"/>
              <a:ext cx="405753" cy="135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Box 32"/>
          <p:cNvSpPr txBox="1"/>
          <p:nvPr/>
        </p:nvSpPr>
        <p:spPr>
          <a:xfrm>
            <a:off x="5629238" y="3078992"/>
            <a:ext cx="15121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Gel 4 Actin	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097632" y="2049214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142220" y="4555569"/>
            <a:ext cx="5333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/>
              <a:t>Actin</a:t>
            </a:r>
          </a:p>
        </p:txBody>
      </p:sp>
      <p:sp>
        <p:nvSpPr>
          <p:cNvPr id="4" name="Rectangle 3"/>
          <p:cNvSpPr/>
          <p:nvPr/>
        </p:nvSpPr>
        <p:spPr>
          <a:xfrm>
            <a:off x="161373" y="5915344"/>
            <a:ext cx="763283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>
                <a:solidFill>
                  <a:srgbClr val="1D2228"/>
                </a:solidFill>
                <a:latin typeface="Helvetica Neue"/>
              </a:rPr>
              <a:t>Membranes were cut and probed simultaneously for SRB1 and actin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20063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153</Words>
  <Application>Microsoft Office PowerPoint</Application>
  <PresentationFormat>On-screen Show (4:3)</PresentationFormat>
  <Paragraphs>8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Helvetica Neu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Peter MacCallum Cancer Cent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der Tanjina</dc:creator>
  <cp:lastModifiedBy>Kader Tanjina</cp:lastModifiedBy>
  <cp:revision>32</cp:revision>
  <dcterms:created xsi:type="dcterms:W3CDTF">2019-11-26T09:35:45Z</dcterms:created>
  <dcterms:modified xsi:type="dcterms:W3CDTF">2020-01-05T00:15:04Z</dcterms:modified>
</cp:coreProperties>
</file>